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14" y="27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52380;&#50672;&#47932;&#54868;&#54617;&#49892;&#51088;&#47308;\&#50696;&#51064;\&#48516;&#49437;&#48277;&#50976;&#54952;&#49457;&#44160;&#51613;\&#50857;&#47588;&#48324;%20&#52628;&#52636;-%20%25MeO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52380;&#50672;&#47932;&#54868;&#54617;&#49892;&#51088;&#47308;\&#50696;&#51064;\&#48516;&#49437;&#48277;&#50976;&#54952;&#49457;&#44160;&#51613;\&#50857;&#47588;&#48324;%20&#52628;&#52636;-%20&#48169;&#48277;,%20&#49884;&#44036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52380;&#50672;&#47932;&#54868;&#54617;&#49892;&#51088;&#47308;\&#50696;&#51064;\&#48516;&#49437;&#48277;&#50976;&#54952;&#49457;&#44160;&#51613;\&#50857;&#47588;&#48324;%20&#52628;&#52636;-%20&#48169;&#48277;,%20&#49884;&#44036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568245988457374"/>
          <c:y val="5.0925925925925923E-2"/>
          <c:w val="0.72437357190757401"/>
          <c:h val="0.84167468649752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정리!$A$78</c:f>
              <c:strCache>
                <c:ptCount val="1"/>
                <c:pt idx="0">
                  <c:v>Total content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 w="0">
              <a:noFill/>
            </a:ln>
            <a:effectLst>
              <a:outerShdw blurRad="50800" dist="50800" dir="5400000" sx="1000" sy="1000" algn="ctr" rotWithShape="0">
                <a:srgbClr val="000000">
                  <a:alpha val="43137"/>
                </a:srgbClr>
              </a:outerShdw>
            </a:effectLst>
          </c:spPr>
          <c:invertIfNegative val="0"/>
          <c:cat>
            <c:strRef>
              <c:f>정리!$B$77:$E$77</c:f>
              <c:strCache>
                <c:ptCount val="4"/>
                <c:pt idx="0">
                  <c:v>40% MeOH</c:v>
                </c:pt>
                <c:pt idx="1">
                  <c:v>60% MeOH</c:v>
                </c:pt>
                <c:pt idx="2">
                  <c:v>70% MeOH</c:v>
                </c:pt>
                <c:pt idx="3">
                  <c:v>100% MeOH</c:v>
                </c:pt>
              </c:strCache>
            </c:strRef>
          </c:cat>
          <c:val>
            <c:numRef>
              <c:f>정리!$B$78:$E$78</c:f>
              <c:numCache>
                <c:formatCode>General</c:formatCode>
                <c:ptCount val="4"/>
                <c:pt idx="0">
                  <c:v>100.46385860485552</c:v>
                </c:pt>
                <c:pt idx="1">
                  <c:v>107.14556979059046</c:v>
                </c:pt>
                <c:pt idx="2">
                  <c:v>180.14124114279247</c:v>
                </c:pt>
                <c:pt idx="3">
                  <c:v>46.8582469824693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44-4F4C-82AF-DFA41732A1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1"/>
        <c:overlap val="-100"/>
        <c:axId val="31156480"/>
        <c:axId val="47212032"/>
      </c:barChart>
      <c:catAx>
        <c:axId val="31156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7212032"/>
        <c:crosses val="autoZero"/>
        <c:auto val="1"/>
        <c:lblAlgn val="ctr"/>
        <c:lblOffset val="100"/>
        <c:noMultiLvlLbl val="0"/>
      </c:catAx>
      <c:valAx>
        <c:axId val="47212032"/>
        <c:scaling>
          <c:orientation val="minMax"/>
          <c:max val="2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ko-KR" altLang="en-US" sz="1100" b="1" baseline="0" dirty="0">
                    <a:solidFill>
                      <a:schemeClr val="tx1"/>
                    </a:solidFill>
                  </a:rPr>
                  <a:t>㎍</a:t>
                </a:r>
                <a:r>
                  <a:rPr lang="en-US" altLang="ko-KR" sz="1100" b="1" baseline="0" dirty="0">
                    <a:solidFill>
                      <a:schemeClr val="tx1"/>
                    </a:solidFill>
                  </a:rPr>
                  <a:t> / </a:t>
                </a:r>
                <a:r>
                  <a:rPr lang="en-US" altLang="ko-KR" sz="1100" b="1" dirty="0">
                    <a:solidFill>
                      <a:schemeClr val="tx1"/>
                    </a:solidFill>
                  </a:rPr>
                  <a:t>g</a:t>
                </a:r>
              </a:p>
            </c:rich>
          </c:tx>
          <c:layout>
            <c:manualLayout>
              <c:xMode val="edge"/>
              <c:yMode val="edge"/>
              <c:x val="4.5846254486398022E-2"/>
              <c:y val="0.41329844298722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out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1156480"/>
        <c:crosses val="autoZero"/>
        <c:crossBetween val="between"/>
        <c:majorUnit val="100"/>
        <c:min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2024786109823392"/>
          <c:y val="3.3876776317975137E-2"/>
          <c:w val="0.52308515383530085"/>
          <c:h val="0.8321559718791231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정리!$A$55</c:f>
              <c:strCache>
                <c:ptCount val="1"/>
                <c:pt idx="0">
                  <c:v>Total content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정리!$B$53:$D$54</c:f>
              <c:multiLvlStrCache>
                <c:ptCount val="3"/>
                <c:lvl>
                  <c:pt idx="0">
                    <c:v>30min</c:v>
                  </c:pt>
                  <c:pt idx="1">
                    <c:v>60min</c:v>
                  </c:pt>
                  <c:pt idx="2">
                    <c:v>90min</c:v>
                  </c:pt>
                </c:lvl>
                <c:lvl>
                  <c:pt idx="0">
                    <c:v>Sonication</c:v>
                  </c:pt>
                </c:lvl>
              </c:multiLvlStrCache>
            </c:multiLvlStrRef>
          </c:cat>
          <c:val>
            <c:numRef>
              <c:f>정리!$B$55:$D$55</c:f>
              <c:numCache>
                <c:formatCode>General</c:formatCode>
                <c:ptCount val="3"/>
                <c:pt idx="0">
                  <c:v>114.83189652678227</c:v>
                </c:pt>
                <c:pt idx="1">
                  <c:v>131.00456211957106</c:v>
                </c:pt>
                <c:pt idx="2">
                  <c:v>128.357440506868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11-48F4-B1F9-84F720EF4A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overlap val="-27"/>
        <c:axId val="47390080"/>
        <c:axId val="47395968"/>
      </c:barChart>
      <c:catAx>
        <c:axId val="473900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7395968"/>
        <c:crosses val="autoZero"/>
        <c:auto val="1"/>
        <c:lblAlgn val="ctr"/>
        <c:lblOffset val="100"/>
        <c:noMultiLvlLbl val="0"/>
      </c:catAx>
      <c:valAx>
        <c:axId val="47395968"/>
        <c:scaling>
          <c:orientation val="minMax"/>
          <c:max val="2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ko-KR" altLang="ko-KR" sz="1100" b="1" i="0" baseline="0" dirty="0">
                    <a:solidFill>
                      <a:schemeClr val="tx1"/>
                    </a:solidFill>
                    <a:effectLst/>
                  </a:rPr>
                  <a:t>㎍</a:t>
                </a:r>
                <a:r>
                  <a:rPr lang="en-US" altLang="ko-KR" sz="1100" b="1" i="0" baseline="0" dirty="0">
                    <a:solidFill>
                      <a:schemeClr val="tx1"/>
                    </a:solidFill>
                    <a:effectLst/>
                  </a:rPr>
                  <a:t> / g</a:t>
                </a:r>
                <a:endParaRPr lang="ko-KR" altLang="ko-KR" sz="1100" b="1" dirty="0">
                  <a:solidFill>
                    <a:schemeClr val="tx1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out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7390080"/>
        <c:crosses val="autoZero"/>
        <c:crossBetween val="between"/>
        <c:majorUnit val="100"/>
        <c:min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ko-KR">
                <a:solidFill>
                  <a:schemeClr val="bg1"/>
                </a:solidFill>
              </a:rPr>
              <a:t>Total conten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31518066197127287"/>
          <c:y val="0.1225651166816453"/>
          <c:w val="0.56501321640758984"/>
          <c:h val="0.7568381274791424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정리!$A$62</c:f>
              <c:strCache>
                <c:ptCount val="1"/>
                <c:pt idx="0">
                  <c:v>Total content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정리!$B$60:$D$61</c:f>
              <c:multiLvlStrCache>
                <c:ptCount val="3"/>
                <c:lvl>
                  <c:pt idx="0">
                    <c:v>30min</c:v>
                  </c:pt>
                  <c:pt idx="1">
                    <c:v>60min</c:v>
                  </c:pt>
                  <c:pt idx="2">
                    <c:v>90min</c:v>
                  </c:pt>
                </c:lvl>
                <c:lvl>
                  <c:pt idx="0">
                    <c:v>Reflux</c:v>
                  </c:pt>
                </c:lvl>
              </c:multiLvlStrCache>
            </c:multiLvlStrRef>
          </c:cat>
          <c:val>
            <c:numRef>
              <c:f>정리!$B$62:$D$62</c:f>
              <c:numCache>
                <c:formatCode>General</c:formatCode>
                <c:ptCount val="3"/>
                <c:pt idx="0">
                  <c:v>151.25715031372596</c:v>
                </c:pt>
                <c:pt idx="1">
                  <c:v>182.37509592808897</c:v>
                </c:pt>
                <c:pt idx="2">
                  <c:v>171.136286142523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D0-4426-8D40-F248293DB7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overlap val="-27"/>
        <c:axId val="47457408"/>
        <c:axId val="47458944"/>
      </c:barChart>
      <c:catAx>
        <c:axId val="47457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7458944"/>
        <c:crosses val="autoZero"/>
        <c:auto val="1"/>
        <c:lblAlgn val="ctr"/>
        <c:lblOffset val="100"/>
        <c:noMultiLvlLbl val="0"/>
      </c:catAx>
      <c:valAx>
        <c:axId val="4745894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ko-KR"/>
          </a:p>
        </c:txPr>
        <c:crossAx val="47457408"/>
        <c:crosses val="autoZero"/>
        <c:crossBetween val="between"/>
        <c:majorUnit val="100"/>
        <c:min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7974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3264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0889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490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1813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5204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5321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4737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4263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6919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69440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E1A51E-755F-451C-89D7-CCC9E401766E}" type="datetimeFigureOut">
              <a:rPr lang="ko-KR" altLang="en-US" smtClean="0"/>
              <a:t>2022-10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2442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그룹 13"/>
          <p:cNvGrpSpPr/>
          <p:nvPr/>
        </p:nvGrpSpPr>
        <p:grpSpPr>
          <a:xfrm>
            <a:off x="1966358" y="1443134"/>
            <a:ext cx="3876718" cy="4022125"/>
            <a:chOff x="1851063" y="1225451"/>
            <a:chExt cx="3104666" cy="3521674"/>
          </a:xfrm>
        </p:grpSpPr>
        <p:graphicFrame>
          <p:nvGraphicFramePr>
            <p:cNvPr id="2" name="차트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13040014"/>
                </p:ext>
              </p:extLst>
            </p:nvPr>
          </p:nvGraphicFramePr>
          <p:xfrm>
            <a:off x="1851063" y="1225451"/>
            <a:ext cx="3104666" cy="352167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1" name="TextBox 10"/>
            <p:cNvSpPr txBox="1"/>
            <p:nvPr/>
          </p:nvSpPr>
          <p:spPr>
            <a:xfrm>
              <a:off x="2572535" y="1416176"/>
              <a:ext cx="5999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" name="그룹 12"/>
          <p:cNvGrpSpPr/>
          <p:nvPr/>
        </p:nvGrpSpPr>
        <p:grpSpPr>
          <a:xfrm>
            <a:off x="5198096" y="1029731"/>
            <a:ext cx="4479305" cy="4523305"/>
            <a:chOff x="5340199" y="965887"/>
            <a:chExt cx="4479305" cy="4523305"/>
          </a:xfrm>
        </p:grpSpPr>
        <p:grpSp>
          <p:nvGrpSpPr>
            <p:cNvPr id="10" name="그룹 9"/>
            <p:cNvGrpSpPr/>
            <p:nvPr/>
          </p:nvGrpSpPr>
          <p:grpSpPr>
            <a:xfrm>
              <a:off x="5340199" y="965887"/>
              <a:ext cx="4479305" cy="4523305"/>
              <a:chOff x="6075426" y="934995"/>
              <a:chExt cx="4479305" cy="4523305"/>
            </a:xfrm>
          </p:grpSpPr>
          <p:graphicFrame>
            <p:nvGraphicFramePr>
              <p:cNvPr id="3" name="차트 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811920179"/>
                  </p:ext>
                </p:extLst>
              </p:nvPr>
            </p:nvGraphicFramePr>
            <p:xfrm>
              <a:off x="6075426" y="1471640"/>
              <a:ext cx="2276835" cy="398665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4" name="차트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62432871"/>
                  </p:ext>
                </p:extLst>
              </p:nvPr>
            </p:nvGraphicFramePr>
            <p:xfrm>
              <a:off x="8357287" y="934995"/>
              <a:ext cx="2115065" cy="452330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cxnSp>
            <p:nvCxnSpPr>
              <p:cNvPr id="5" name="직선 연결선 4"/>
              <p:cNvCxnSpPr/>
              <p:nvPr/>
            </p:nvCxnSpPr>
            <p:spPr>
              <a:xfrm>
                <a:off x="7018605" y="4923399"/>
                <a:ext cx="353612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" name="TextBox 11"/>
            <p:cNvSpPr txBox="1"/>
            <p:nvPr/>
          </p:nvSpPr>
          <p:spPr>
            <a:xfrm>
              <a:off x="6350018" y="1597118"/>
              <a:ext cx="6425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562377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4</Words>
  <Application>Microsoft Office PowerPoint</Application>
  <PresentationFormat>와이드스크린</PresentationFormat>
  <Paragraphs>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aein3696@naver.com</dc:creator>
  <cp:lastModifiedBy>user</cp:lastModifiedBy>
  <cp:revision>11</cp:revision>
  <dcterms:created xsi:type="dcterms:W3CDTF">2018-12-21T03:52:09Z</dcterms:created>
  <dcterms:modified xsi:type="dcterms:W3CDTF">2022-10-05T02:18:11Z</dcterms:modified>
</cp:coreProperties>
</file>